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DACABEA-F9B2-41CF-A9F3-08AD78374DA0}" v="5" dt="2026-03-31T00:52:57.7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S::megumi_tatsumi@ncnp.go.jp::88b1893c-db63-4bb5-9dca-a6ce3447aab8" providerId="AD" clId="Web-{DDACABEA-F9B2-41CF-A9F3-08AD78374DA0}"/>
    <pc:docChg chg="modSld">
      <pc:chgData name="辰巳　めぐみ" userId="S::megumi_tatsumi@ncnp.go.jp::88b1893c-db63-4bb5-9dca-a6ce3447aab8" providerId="AD" clId="Web-{DDACABEA-F9B2-41CF-A9F3-08AD78374DA0}" dt="2026-03-31T00:52:55.195" v="1" actId="20577"/>
      <pc:docMkLst>
        <pc:docMk/>
      </pc:docMkLst>
      <pc:sldChg chg="modSp">
        <pc:chgData name="辰巳　めぐみ" userId="S::megumi_tatsumi@ncnp.go.jp::88b1893c-db63-4bb5-9dca-a6ce3447aab8" providerId="AD" clId="Web-{DDACABEA-F9B2-41CF-A9F3-08AD78374DA0}" dt="2026-03-31T00:52:55.195" v="1" actId="20577"/>
        <pc:sldMkLst>
          <pc:docMk/>
          <pc:sldMk cId="3285713202" sldId="256"/>
        </pc:sldMkLst>
        <pc:spChg chg="mod">
          <ac:chgData name="辰巳　めぐみ" userId="S::megumi_tatsumi@ncnp.go.jp::88b1893c-db63-4bb5-9dca-a6ce3447aab8" providerId="AD" clId="Web-{DDACABEA-F9B2-41CF-A9F3-08AD78374DA0}" dt="2026-03-31T00:52:55.195" v="1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4606048"/>
            <a:ext cx="6854109" cy="30777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Figure </a:t>
            </a:r>
            <a:r>
              <a:rPr lang="en-US" altLang="ja-JP" sz="1400" b="1" dirty="0">
                <a:latin typeface="Times"/>
                <a:ea typeface="游明朝"/>
                <a:cs typeface="Times New Roman"/>
              </a:rPr>
              <a:t>S6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.</a:t>
            </a:r>
            <a:r>
              <a:rPr lang="en-US" altLang="ja-JP" sz="1400" dirty="0">
                <a:effectLst/>
                <a:latin typeface="Times"/>
                <a:ea typeface="游明朝"/>
                <a:cs typeface="Times New Roman"/>
              </a:rPr>
              <a:t> 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Impact of hemolysis on the plasma proteome analyzed by volcano plot.</a:t>
            </a:r>
            <a:endParaRPr lang="ja-JP" altLang="ja-JP" sz="1400" dirty="0">
              <a:effectLst/>
              <a:latin typeface="Times"/>
              <a:ea typeface="游明朝"/>
              <a:cs typeface="Times New Roman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24FD1D4-0809-915F-D366-5504CB4CD467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144922" y="1420859"/>
            <a:ext cx="2628000" cy="2628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A18CC2-4B3D-DFC5-79DD-5988D33B7636}"/>
              </a:ext>
            </a:extLst>
          </p:cNvPr>
          <p:cNvSpPr txBox="1"/>
          <p:nvPr/>
        </p:nvSpPr>
        <p:spPr>
          <a:xfrm>
            <a:off x="3905792" y="4084025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6E499AC-C8B0-8443-F702-126DC6597383}"/>
              </a:ext>
            </a:extLst>
          </p:cNvPr>
          <p:cNvSpPr txBox="1"/>
          <p:nvPr/>
        </p:nvSpPr>
        <p:spPr>
          <a:xfrm rot="16200000">
            <a:off x="2430784" y="2689091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733E916-9E2A-4786-BD85-7ADD6D89B6E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808179E-FF95-4A68-974B-553FA0EF9D30}">
  <ds:schemaRefs>
    <ds:schemaRef ds:uri="09e658bc-5f5e-48b2-a593-8f2a4dff4e86"/>
    <ds:schemaRef ds:uri="http://purl.org/dc/terms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schemas.microsoft.com/office/2006/metadata/properties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1E5254FA-07C6-4E12-84B3-644BFF059DB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</TotalTime>
  <Words>21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Times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8</cp:revision>
  <dcterms:created xsi:type="dcterms:W3CDTF">2025-03-28T03:13:18Z</dcterms:created>
  <dcterms:modified xsi:type="dcterms:W3CDTF">2026-03-31T07:5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